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8"/>
  </p:notesMasterIdLst>
  <p:sldIdLst>
    <p:sldId id="281" r:id="rId2"/>
    <p:sldId id="288" r:id="rId3"/>
    <p:sldId id="296" r:id="rId4"/>
    <p:sldId id="299" r:id="rId5"/>
    <p:sldId id="297" r:id="rId6"/>
    <p:sldId id="300" r:id="rId7"/>
  </p:sldIdLst>
  <p:sldSz cx="6858000" cy="9906000" type="A4"/>
  <p:notesSz cx="6889750" cy="100218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2080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2611" autoAdjust="0"/>
  </p:normalViewPr>
  <p:slideViewPr>
    <p:cSldViewPr snapToGrid="0">
      <p:cViewPr varScale="1">
        <p:scale>
          <a:sx n="79" d="100"/>
          <a:sy n="79" d="100"/>
        </p:scale>
        <p:origin x="314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210.107.214.227\306b%20pdgl\&#51221;&#44592;\LHT%20&#44288;&#47144;%20&#49892;&#54744;data%202016%2008%2025\LHT3\LHT3ox\151030%20qRT%20LHT3ox%20confirm%20-%20PP2A-LHT3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umin%20Lee\Desktop\LHT%20data\LHT2ox\qRT%20LHT2ox%20T3--LHT2-PP2A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umin%20Lee\Desktop\LHT%20data\are2%20AAP1\qRT%20AAP1AAP5%20ox_Nov22_2018_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D:\2018-frontier%20ACC%20transporter\LHT%20data\160601%20elslhtKO%20db%20ACC%20dose\160601%20elslhtKO%20db%20ACC%20dose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4472752357494337"/>
          <c:y val="9.2172119457969881E-2"/>
          <c:w val="0.65947784037610191"/>
          <c:h val="0.8709590327588421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151030 qRT LHT3ox confirm - PP2A-LHT3.xlsx]Sheet8'!$H$48:$H$51</c:f>
                <c:numCache>
                  <c:formatCode>General</c:formatCode>
                  <c:ptCount val="4"/>
                  <c:pt idx="0">
                    <c:v>0.51980715147048173</c:v>
                  </c:pt>
                  <c:pt idx="1">
                    <c:v>0.15873016266091949</c:v>
                  </c:pt>
                  <c:pt idx="2">
                    <c:v>59.047262014979218</c:v>
                  </c:pt>
                  <c:pt idx="3">
                    <c:v>9.8806723504793012E-2</c:v>
                  </c:pt>
                </c:numCache>
              </c:numRef>
            </c:plus>
            <c:minus>
              <c:numRef>
                <c:f>'[151030 qRT LHT3ox confirm - PP2A-LHT3.xlsx]Sheet8'!$H$48:$H$51</c:f>
                <c:numCache>
                  <c:formatCode>General</c:formatCode>
                  <c:ptCount val="4"/>
                  <c:pt idx="0">
                    <c:v>0.51980715147048173</c:v>
                  </c:pt>
                  <c:pt idx="1">
                    <c:v>0.15873016266091949</c:v>
                  </c:pt>
                  <c:pt idx="2">
                    <c:v>59.047262014979218</c:v>
                  </c:pt>
                  <c:pt idx="3">
                    <c:v>9.880672350479301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151030 qRT LHT3ox confirm - PP2A-LHT3.xlsx]Sheet8'!$F$48:$F$51</c:f>
              <c:strCache>
                <c:ptCount val="4"/>
                <c:pt idx="0">
                  <c:v>Col</c:v>
                </c:pt>
                <c:pt idx="1">
                  <c:v>are2</c:v>
                </c:pt>
                <c:pt idx="2">
                  <c:v>are2LHT3ox-7</c:v>
                </c:pt>
                <c:pt idx="3">
                  <c:v>are2LHT3ox-17</c:v>
                </c:pt>
              </c:strCache>
            </c:strRef>
          </c:cat>
          <c:val>
            <c:numRef>
              <c:f>'[151030 qRT LHT3ox confirm - PP2A-LHT3.xlsx]Sheet8'!$G$48:$G$51</c:f>
              <c:numCache>
                <c:formatCode>General</c:formatCode>
                <c:ptCount val="4"/>
                <c:pt idx="0">
                  <c:v>1.0785339170168828</c:v>
                </c:pt>
                <c:pt idx="1">
                  <c:v>0.61723465552974432</c:v>
                </c:pt>
                <c:pt idx="2">
                  <c:v>773.36879457542557</c:v>
                </c:pt>
                <c:pt idx="3">
                  <c:v>0.563685938178147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FA6-4142-B2F1-82A2EE3D839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24426543"/>
        <c:axId val="1967119823"/>
      </c:barChart>
      <c:catAx>
        <c:axId val="1724426543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967119823"/>
        <c:crosses val="autoZero"/>
        <c:auto val="1"/>
        <c:lblAlgn val="ctr"/>
        <c:lblOffset val="100"/>
        <c:noMultiLvlLbl val="0"/>
      </c:catAx>
      <c:valAx>
        <c:axId val="196711982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LID4096"/>
          </a:p>
        </c:txPr>
        <c:crossAx val="1724426543"/>
        <c:crosses val="autoZero"/>
        <c:crossBetween val="between"/>
      </c:valAx>
      <c:spPr>
        <a:noFill/>
        <a:ln>
          <a:solidFill>
            <a:sysClr val="windowText" lastClr="000000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LID4096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5777057479736282"/>
          <c:y val="6.3349908331904459E-2"/>
          <c:w val="0.68773942346936923"/>
          <c:h val="0.8860561305124025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6!$P$25:$P$28</c:f>
                <c:numCache>
                  <c:formatCode>General</c:formatCode>
                  <c:ptCount val="4"/>
                  <c:pt idx="0">
                    <c:v>0.2316924544219979</c:v>
                  </c:pt>
                  <c:pt idx="1">
                    <c:v>0.47920218850426338</c:v>
                  </c:pt>
                  <c:pt idx="2">
                    <c:v>26.769470358419589</c:v>
                  </c:pt>
                  <c:pt idx="3">
                    <c:v>0.7095633107429663</c:v>
                  </c:pt>
                </c:numCache>
              </c:numRef>
            </c:plus>
            <c:minus>
              <c:numRef>
                <c:f>Sheet6!$P$25:$P$28</c:f>
                <c:numCache>
                  <c:formatCode>General</c:formatCode>
                  <c:ptCount val="4"/>
                  <c:pt idx="0">
                    <c:v>0.2316924544219979</c:v>
                  </c:pt>
                  <c:pt idx="1">
                    <c:v>0.47920218850426338</c:v>
                  </c:pt>
                  <c:pt idx="2">
                    <c:v>26.769470358419589</c:v>
                  </c:pt>
                  <c:pt idx="3">
                    <c:v>0.709563310742966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6!$O$18:$O$21</c:f>
              <c:strCache>
                <c:ptCount val="4"/>
                <c:pt idx="0">
                  <c:v>Col</c:v>
                </c:pt>
                <c:pt idx="1">
                  <c:v>lht1are2</c:v>
                </c:pt>
                <c:pt idx="2">
                  <c:v>are2LHT2ox-1</c:v>
                </c:pt>
                <c:pt idx="3">
                  <c:v>are2LHT2ox-3</c:v>
                </c:pt>
              </c:strCache>
            </c:strRef>
          </c:cat>
          <c:val>
            <c:numRef>
              <c:f>Sheet6!$P$18:$P$21</c:f>
              <c:numCache>
                <c:formatCode>General</c:formatCode>
                <c:ptCount val="4"/>
                <c:pt idx="0">
                  <c:v>1.0178594717049749</c:v>
                </c:pt>
                <c:pt idx="1">
                  <c:v>2.3569336015425431</c:v>
                </c:pt>
                <c:pt idx="2">
                  <c:v>103.65108963189033</c:v>
                </c:pt>
                <c:pt idx="3">
                  <c:v>12.99935246450957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C1A-4509-92E5-274D8B89014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6918383"/>
        <c:axId val="106912975"/>
      </c:barChart>
      <c:catAx>
        <c:axId val="106918383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06912975"/>
        <c:crosses val="autoZero"/>
        <c:auto val="1"/>
        <c:lblAlgn val="ctr"/>
        <c:lblOffset val="100"/>
        <c:noMultiLvlLbl val="0"/>
      </c:catAx>
      <c:valAx>
        <c:axId val="106912975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LID4096"/>
          </a:p>
        </c:txPr>
        <c:crossAx val="106918383"/>
        <c:crosses val="autoZero"/>
        <c:crossBetween val="between"/>
      </c:valAx>
      <c:spPr>
        <a:noFill/>
        <a:ln>
          <a:solidFill>
            <a:sysClr val="windowText" lastClr="000000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LID4096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149991668503963"/>
          <c:y val="0.12632707672519972"/>
          <c:w val="0.69533065124648641"/>
          <c:h val="0.7733015052919568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C$38:$C$41</c:f>
                <c:numCache>
                  <c:formatCode>General</c:formatCode>
                  <c:ptCount val="4"/>
                  <c:pt idx="0">
                    <c:v>0.14385205295146755</c:v>
                  </c:pt>
                  <c:pt idx="1">
                    <c:v>2.1365359701196334E-2</c:v>
                  </c:pt>
                  <c:pt idx="2">
                    <c:v>0.21115289294737014</c:v>
                  </c:pt>
                  <c:pt idx="3">
                    <c:v>1.4058580868430037</c:v>
                  </c:pt>
                </c:numCache>
              </c:numRef>
            </c:plus>
            <c:minus>
              <c:numRef>
                <c:f>Sheet1!$C$38:$C$41</c:f>
                <c:numCache>
                  <c:formatCode>General</c:formatCode>
                  <c:ptCount val="4"/>
                  <c:pt idx="0">
                    <c:v>0.14385205295146755</c:v>
                  </c:pt>
                  <c:pt idx="1">
                    <c:v>2.1365359701196334E-2</c:v>
                  </c:pt>
                  <c:pt idx="2">
                    <c:v>0.21115289294737014</c:v>
                  </c:pt>
                  <c:pt idx="3">
                    <c:v>1.405858086843003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38:$A$41</c:f>
              <c:strCache>
                <c:ptCount val="4"/>
                <c:pt idx="0">
                  <c:v>Col</c:v>
                </c:pt>
                <c:pt idx="1">
                  <c:v>are2</c:v>
                </c:pt>
                <c:pt idx="2">
                  <c:v>AAP5 ox 4</c:v>
                </c:pt>
                <c:pt idx="3">
                  <c:v>AAP5 ox 14</c:v>
                </c:pt>
              </c:strCache>
            </c:strRef>
          </c:cat>
          <c:val>
            <c:numRef>
              <c:f>Sheet1!$B$38:$B$41</c:f>
              <c:numCache>
                <c:formatCode>General</c:formatCode>
                <c:ptCount val="4"/>
                <c:pt idx="0">
                  <c:v>1.006520796444428</c:v>
                </c:pt>
                <c:pt idx="1">
                  <c:v>0.71414499167177947</c:v>
                </c:pt>
                <c:pt idx="2">
                  <c:v>3.3002914551710538</c:v>
                </c:pt>
                <c:pt idx="3">
                  <c:v>18.07980216068304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9EB-47F3-81D8-27C2250C10A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80546400"/>
        <c:axId val="1080565120"/>
      </c:barChart>
      <c:catAx>
        <c:axId val="1080546400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080565120"/>
        <c:crosses val="autoZero"/>
        <c:auto val="1"/>
        <c:lblAlgn val="ctr"/>
        <c:lblOffset val="100"/>
        <c:noMultiLvlLbl val="0"/>
      </c:catAx>
      <c:valAx>
        <c:axId val="108056512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LID4096"/>
          </a:p>
        </c:txPr>
        <c:crossAx val="1080546400"/>
        <c:crosses val="autoZero"/>
        <c:crossBetween val="between"/>
      </c:valAx>
      <c:spPr>
        <a:noFill/>
        <a:ln>
          <a:solidFill>
            <a:sysClr val="windowText" lastClr="000000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LID4096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2886482939632541E-2"/>
          <c:y val="5.0925925925925923E-2"/>
          <c:w val="0.89655796150481193"/>
          <c:h val="0.9064895013123359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W$106</c:f>
              <c:strCache>
                <c:ptCount val="1"/>
                <c:pt idx="0">
                  <c:v>1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W$115</c:f>
                <c:numCache>
                  <c:formatCode>General</c:formatCode>
                  <c:ptCount val="1"/>
                  <c:pt idx="0">
                    <c:v>0.50506670940815213</c:v>
                  </c:pt>
                </c:numCache>
              </c:numRef>
            </c:plus>
            <c:minus>
              <c:numRef>
                <c:f>Sheet1!$W$112:$W$115</c:f>
                <c:numCache>
                  <c:formatCode>General</c:formatCode>
                  <c:ptCount val="4"/>
                  <c:pt idx="0">
                    <c:v>0.28468696258639586</c:v>
                  </c:pt>
                  <c:pt idx="1">
                    <c:v>0.35623427283580839</c:v>
                  </c:pt>
                  <c:pt idx="2">
                    <c:v>0.2</c:v>
                  </c:pt>
                  <c:pt idx="3">
                    <c:v>0.5050667094081521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V$107:$V$110</c:f>
              <c:strCache>
                <c:ptCount val="4"/>
                <c:pt idx="0">
                  <c:v>col</c:v>
                </c:pt>
                <c:pt idx="1">
                  <c:v>are2</c:v>
                </c:pt>
                <c:pt idx="2">
                  <c:v>lht2-1</c:v>
                </c:pt>
                <c:pt idx="3">
                  <c:v>are2lht2-1</c:v>
                </c:pt>
              </c:strCache>
            </c:strRef>
          </c:cat>
          <c:val>
            <c:numRef>
              <c:f>Sheet1!$W$107:$W$110</c:f>
              <c:numCache>
                <c:formatCode>General</c:formatCode>
                <c:ptCount val="4"/>
                <c:pt idx="0">
                  <c:v>2.0825</c:v>
                </c:pt>
                <c:pt idx="1">
                  <c:v>4.7379999999999995</c:v>
                </c:pt>
                <c:pt idx="2">
                  <c:v>2</c:v>
                </c:pt>
                <c:pt idx="3">
                  <c:v>4.2626666666666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FD5-4F5B-A8EB-B0D9A8515173}"/>
            </c:ext>
          </c:extLst>
        </c:ser>
        <c:ser>
          <c:idx val="1"/>
          <c:order val="1"/>
          <c:tx>
            <c:strRef>
              <c:f>Sheet1!$X$106</c:f>
              <c:strCache>
                <c:ptCount val="1"/>
                <c:pt idx="0">
                  <c:v>5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X$112:$X$115</c:f>
                <c:numCache>
                  <c:formatCode>General</c:formatCode>
                  <c:ptCount val="4"/>
                  <c:pt idx="0">
                    <c:v>0.23497112284582758</c:v>
                  </c:pt>
                  <c:pt idx="1">
                    <c:v>0.35479303155233233</c:v>
                  </c:pt>
                  <c:pt idx="2">
                    <c:v>0.7</c:v>
                  </c:pt>
                  <c:pt idx="3">
                    <c:v>0.29037834515220712</c:v>
                  </c:pt>
                </c:numCache>
              </c:numRef>
            </c:plus>
            <c:minus>
              <c:numRef>
                <c:f>Sheet1!$X$112:$X$115</c:f>
                <c:numCache>
                  <c:formatCode>General</c:formatCode>
                  <c:ptCount val="4"/>
                  <c:pt idx="0">
                    <c:v>0.23497112284582758</c:v>
                  </c:pt>
                  <c:pt idx="1">
                    <c:v>0.35479303155233233</c:v>
                  </c:pt>
                  <c:pt idx="2">
                    <c:v>0.7</c:v>
                  </c:pt>
                  <c:pt idx="3">
                    <c:v>0.2903783451522071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V$107:$V$110</c:f>
              <c:strCache>
                <c:ptCount val="4"/>
                <c:pt idx="0">
                  <c:v>col</c:v>
                </c:pt>
                <c:pt idx="1">
                  <c:v>are2</c:v>
                </c:pt>
                <c:pt idx="2">
                  <c:v>lht2-1</c:v>
                </c:pt>
                <c:pt idx="3">
                  <c:v>are2lht2-1</c:v>
                </c:pt>
              </c:strCache>
            </c:strRef>
          </c:cat>
          <c:val>
            <c:numRef>
              <c:f>Sheet1!$X$107:$X$110</c:f>
              <c:numCache>
                <c:formatCode>General</c:formatCode>
                <c:ptCount val="4"/>
                <c:pt idx="0">
                  <c:v>1.4239999999999999</c:v>
                </c:pt>
                <c:pt idx="1">
                  <c:v>2.5473333333333334</c:v>
                </c:pt>
                <c:pt idx="2">
                  <c:v>1.37</c:v>
                </c:pt>
                <c:pt idx="3">
                  <c:v>2.425625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FD5-4F5B-A8EB-B0D9A8515173}"/>
            </c:ext>
          </c:extLst>
        </c:ser>
        <c:ser>
          <c:idx val="2"/>
          <c:order val="2"/>
          <c:tx>
            <c:strRef>
              <c:f>Sheet1!$Y$106</c:f>
              <c:strCache>
                <c:ptCount val="1"/>
                <c:pt idx="0">
                  <c:v>10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Y$112:$Y$115</c:f>
                <c:numCache>
                  <c:formatCode>General</c:formatCode>
                  <c:ptCount val="4"/>
                  <c:pt idx="0">
                    <c:v>0.1936196566172235</c:v>
                  </c:pt>
                  <c:pt idx="1">
                    <c:v>0.2515154070827485</c:v>
                  </c:pt>
                  <c:pt idx="2">
                    <c:v>0</c:v>
                  </c:pt>
                  <c:pt idx="3">
                    <c:v>0.23174698847378128</c:v>
                  </c:pt>
                </c:numCache>
              </c:numRef>
            </c:plus>
            <c:minus>
              <c:numRef>
                <c:f>Sheet1!$Y$112:$Y$115</c:f>
                <c:numCache>
                  <c:formatCode>General</c:formatCode>
                  <c:ptCount val="4"/>
                  <c:pt idx="0">
                    <c:v>0.1936196566172235</c:v>
                  </c:pt>
                  <c:pt idx="1">
                    <c:v>0.2515154070827485</c:v>
                  </c:pt>
                  <c:pt idx="2">
                    <c:v>0</c:v>
                  </c:pt>
                  <c:pt idx="3">
                    <c:v>0.2317469884737812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V$107:$V$110</c:f>
              <c:strCache>
                <c:ptCount val="4"/>
                <c:pt idx="0">
                  <c:v>col</c:v>
                </c:pt>
                <c:pt idx="1">
                  <c:v>are2</c:v>
                </c:pt>
                <c:pt idx="2">
                  <c:v>lht2-1</c:v>
                </c:pt>
                <c:pt idx="3">
                  <c:v>are2lht2-1</c:v>
                </c:pt>
              </c:strCache>
            </c:strRef>
          </c:cat>
          <c:val>
            <c:numRef>
              <c:f>Sheet1!$Y$107:$Y$110</c:f>
              <c:numCache>
                <c:formatCode>General</c:formatCode>
                <c:ptCount val="4"/>
                <c:pt idx="0">
                  <c:v>1.212</c:v>
                </c:pt>
                <c:pt idx="1">
                  <c:v>2.0780000000000003</c:v>
                </c:pt>
                <c:pt idx="2">
                  <c:v>1.35</c:v>
                </c:pt>
                <c:pt idx="3">
                  <c:v>1.8093333333333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FD5-4F5B-A8EB-B0D9A851517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065072832"/>
        <c:axId val="2065073248"/>
      </c:barChart>
      <c:catAx>
        <c:axId val="2065072832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2065073248"/>
        <c:crosses val="autoZero"/>
        <c:auto val="1"/>
        <c:lblAlgn val="ctr"/>
        <c:lblOffset val="100"/>
        <c:noMultiLvlLbl val="0"/>
      </c:catAx>
      <c:valAx>
        <c:axId val="206507324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LID4096"/>
          </a:p>
        </c:txPr>
        <c:crossAx val="2065072832"/>
        <c:crosses val="autoZero"/>
        <c:crossBetween val="between"/>
      </c:valAx>
      <c:spPr>
        <a:noFill/>
        <a:ln>
          <a:solidFill>
            <a:sysClr val="windowText" lastClr="000000"/>
          </a:solidFill>
        </a:ln>
        <a:effectLst/>
      </c:spPr>
    </c:plotArea>
    <c:legend>
      <c:legendPos val="b"/>
      <c:layout>
        <c:manualLayout>
          <c:xMode val="edge"/>
          <c:yMode val="edge"/>
          <c:x val="0.10072287839020122"/>
          <c:y val="6.5392971711869349E-2"/>
          <c:w val="0.15966535433070866"/>
          <c:h val="7.812554680664918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LID4096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LID4096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6088" cy="5016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902075" y="0"/>
            <a:ext cx="2986088" cy="5016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DE9531E-4D2C-49F4-811D-6D82EBC9FF85}" type="datetimeFigureOut">
              <a:rPr lang="ko-KR" altLang="en-US" smtClean="0"/>
              <a:t>2019-08-26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73300" y="1252538"/>
            <a:ext cx="2343150" cy="33829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8975" y="4822825"/>
            <a:ext cx="5511800" cy="39465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520238"/>
            <a:ext cx="2986088" cy="5016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902075" y="9520238"/>
            <a:ext cx="2986088" cy="5016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8622B1D-209C-4FB1-B4F1-75573B95ADA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377172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E22B77-1687-40B3-AB35-867ABC2117C6}" type="datetimeFigureOut">
              <a:rPr lang="ko-KR" altLang="en-US" smtClean="0"/>
              <a:t>2019-08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BA0F06-887A-4567-9D5C-44EBABE5D3C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871249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E22B77-1687-40B3-AB35-867ABC2117C6}" type="datetimeFigureOut">
              <a:rPr lang="ko-KR" altLang="en-US" smtClean="0"/>
              <a:t>2019-08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BA0F06-887A-4567-9D5C-44EBABE5D3C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283489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E22B77-1687-40B3-AB35-867ABC2117C6}" type="datetimeFigureOut">
              <a:rPr lang="ko-KR" altLang="en-US" smtClean="0"/>
              <a:t>2019-08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BA0F06-887A-4567-9D5C-44EBABE5D3C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686221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E22B77-1687-40B3-AB35-867ABC2117C6}" type="datetimeFigureOut">
              <a:rPr lang="ko-KR" altLang="en-US" smtClean="0"/>
              <a:t>2019-08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BA0F06-887A-4567-9D5C-44EBABE5D3C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108774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E22B77-1687-40B3-AB35-867ABC2117C6}" type="datetimeFigureOut">
              <a:rPr lang="ko-KR" altLang="en-US" smtClean="0"/>
              <a:t>2019-08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BA0F06-887A-4567-9D5C-44EBABE5D3C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939545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E22B77-1687-40B3-AB35-867ABC2117C6}" type="datetimeFigureOut">
              <a:rPr lang="ko-KR" altLang="en-US" smtClean="0"/>
              <a:t>2019-08-2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BA0F06-887A-4567-9D5C-44EBABE5D3C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860637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E22B77-1687-40B3-AB35-867ABC2117C6}" type="datetimeFigureOut">
              <a:rPr lang="ko-KR" altLang="en-US" smtClean="0"/>
              <a:t>2019-08-26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BA0F06-887A-4567-9D5C-44EBABE5D3C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998358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E22B77-1687-40B3-AB35-867ABC2117C6}" type="datetimeFigureOut">
              <a:rPr lang="ko-KR" altLang="en-US" smtClean="0"/>
              <a:t>2019-08-26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BA0F06-887A-4567-9D5C-44EBABE5D3C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619085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E22B77-1687-40B3-AB35-867ABC2117C6}" type="datetimeFigureOut">
              <a:rPr lang="ko-KR" altLang="en-US" smtClean="0"/>
              <a:t>2019-08-26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BA0F06-887A-4567-9D5C-44EBABE5D3C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001860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E22B77-1687-40B3-AB35-867ABC2117C6}" type="datetimeFigureOut">
              <a:rPr lang="ko-KR" altLang="en-US" smtClean="0"/>
              <a:t>2019-08-2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BA0F06-887A-4567-9D5C-44EBABE5D3C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61012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E22B77-1687-40B3-AB35-867ABC2117C6}" type="datetimeFigureOut">
              <a:rPr lang="ko-KR" altLang="en-US" smtClean="0"/>
              <a:t>2019-08-2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BA0F06-887A-4567-9D5C-44EBABE5D3C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875160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E22B77-1687-40B3-AB35-867ABC2117C6}" type="datetimeFigureOut">
              <a:rPr lang="ko-KR" altLang="en-US" smtClean="0"/>
              <a:t>2019-08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BA0F06-887A-4567-9D5C-44EBABE5D3C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64086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4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63791" y="8192977"/>
            <a:ext cx="64527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en-US" altLang="ko-KR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silico</a:t>
            </a:r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analysis of tissue specific expression pattern of </a:t>
            </a:r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LHTs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AAP5.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The expression data was obtained from Arabidopsis 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eFP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browser (</a:t>
            </a:r>
            <a:r>
              <a:rPr lang="en-US" altLang="ko-KR" sz="1200" dirty="0"/>
              <a:t>http://bbc.botany.utoronto.ca/efp/cgi-bin/efpWeb.cgi).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4" name="그룹 23"/>
          <p:cNvGrpSpPr>
            <a:grpSpLocks noChangeAspect="1"/>
          </p:cNvGrpSpPr>
          <p:nvPr/>
        </p:nvGrpSpPr>
        <p:grpSpPr>
          <a:xfrm>
            <a:off x="369912" y="634260"/>
            <a:ext cx="6353738" cy="7241526"/>
            <a:chOff x="349985" y="634260"/>
            <a:chExt cx="6353738" cy="7241526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 rotWithShape="1">
            <a:blip r:embed="rId2"/>
            <a:srcRect l="24794" t="22386" r="26162" b="12923"/>
            <a:stretch/>
          </p:blipFill>
          <p:spPr>
            <a:xfrm>
              <a:off x="349985" y="911260"/>
              <a:ext cx="1969536" cy="146134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" name="그림 5"/>
            <p:cNvPicPr>
              <a:picLocks noChangeAspect="1"/>
            </p:cNvPicPr>
            <p:nvPr/>
          </p:nvPicPr>
          <p:blipFill rotWithShape="1">
            <a:blip r:embed="rId3"/>
            <a:srcRect l="24488" t="26512" r="26410" b="8348"/>
            <a:stretch/>
          </p:blipFill>
          <p:spPr>
            <a:xfrm>
              <a:off x="2534850" y="901550"/>
              <a:ext cx="2008264" cy="149860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7" name="그림 6"/>
            <p:cNvPicPr>
              <a:picLocks noChangeAspect="1"/>
            </p:cNvPicPr>
            <p:nvPr/>
          </p:nvPicPr>
          <p:blipFill rotWithShape="1">
            <a:blip r:embed="rId4"/>
            <a:srcRect l="24498" t="26033" r="26069" b="8243"/>
            <a:stretch/>
          </p:blipFill>
          <p:spPr>
            <a:xfrm>
              <a:off x="4727581" y="894670"/>
              <a:ext cx="1976142" cy="147793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8" name="그림 7"/>
            <p:cNvPicPr>
              <a:picLocks noChangeAspect="1"/>
            </p:cNvPicPr>
            <p:nvPr/>
          </p:nvPicPr>
          <p:blipFill rotWithShape="1">
            <a:blip r:embed="rId5"/>
            <a:srcRect l="25124" t="14976" r="26467" b="19887"/>
            <a:stretch/>
          </p:blipFill>
          <p:spPr>
            <a:xfrm>
              <a:off x="372313" y="2695379"/>
              <a:ext cx="1963100" cy="148586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9" name="그림 8"/>
            <p:cNvPicPr>
              <a:picLocks noChangeAspect="1"/>
            </p:cNvPicPr>
            <p:nvPr/>
          </p:nvPicPr>
          <p:blipFill rotWithShape="1">
            <a:blip r:embed="rId6"/>
            <a:srcRect l="24896" t="14613" r="26136" b="20105"/>
            <a:stretch/>
          </p:blipFill>
          <p:spPr>
            <a:xfrm>
              <a:off x="2547692" y="2673885"/>
              <a:ext cx="1982579" cy="14868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0" name="그림 9"/>
            <p:cNvPicPr>
              <a:picLocks noChangeAspect="1"/>
            </p:cNvPicPr>
            <p:nvPr/>
          </p:nvPicPr>
          <p:blipFill rotWithShape="1">
            <a:blip r:embed="rId7"/>
            <a:srcRect l="24873" t="14616" r="26537" b="20199"/>
            <a:stretch/>
          </p:blipFill>
          <p:spPr>
            <a:xfrm>
              <a:off x="4727581" y="2646810"/>
              <a:ext cx="1969033" cy="148586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1" name="그림 10"/>
            <p:cNvPicPr>
              <a:picLocks noChangeAspect="1"/>
            </p:cNvPicPr>
            <p:nvPr/>
          </p:nvPicPr>
          <p:blipFill rotWithShape="1">
            <a:blip r:embed="rId8"/>
            <a:srcRect l="24167" t="26569" r="26292" b="7482"/>
            <a:stretch/>
          </p:blipFill>
          <p:spPr>
            <a:xfrm>
              <a:off x="372313" y="4487887"/>
              <a:ext cx="1992627" cy="149205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2" name="그림 11"/>
            <p:cNvPicPr>
              <a:picLocks noChangeAspect="1"/>
            </p:cNvPicPr>
            <p:nvPr/>
          </p:nvPicPr>
          <p:blipFill rotWithShape="1">
            <a:blip r:embed="rId9"/>
            <a:srcRect l="24500" t="26352" r="25962" b="8572"/>
            <a:stretch/>
          </p:blipFill>
          <p:spPr>
            <a:xfrm>
              <a:off x="2554363" y="4510551"/>
              <a:ext cx="2007493" cy="14834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3" name="그림 12"/>
            <p:cNvPicPr>
              <a:picLocks noChangeAspect="1"/>
            </p:cNvPicPr>
            <p:nvPr/>
          </p:nvPicPr>
          <p:blipFill rotWithShape="1">
            <a:blip r:embed="rId10"/>
            <a:srcRect l="24639" t="15163" r="26241" b="19516"/>
            <a:stretch/>
          </p:blipFill>
          <p:spPr>
            <a:xfrm>
              <a:off x="4712593" y="4481837"/>
              <a:ext cx="1984021" cy="148410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4" name="그림 13"/>
            <p:cNvPicPr>
              <a:picLocks noChangeAspect="1"/>
            </p:cNvPicPr>
            <p:nvPr/>
          </p:nvPicPr>
          <p:blipFill rotWithShape="1">
            <a:blip r:embed="rId11"/>
            <a:srcRect l="24616" t="14875" r="24946" b="18200"/>
            <a:stretch/>
          </p:blipFill>
          <p:spPr>
            <a:xfrm>
              <a:off x="374051" y="6389846"/>
              <a:ext cx="1990889" cy="148594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3" name="TextBox 2"/>
            <p:cNvSpPr txBox="1"/>
            <p:nvPr/>
          </p:nvSpPr>
          <p:spPr>
            <a:xfrm>
              <a:off x="1032707" y="634260"/>
              <a:ext cx="5613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HT1</a:t>
              </a:r>
              <a:endParaRPr lang="ko-KR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3277424" y="635638"/>
              <a:ext cx="5613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HT2</a:t>
              </a:r>
              <a:endParaRPr lang="ko-KR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5465906" y="634260"/>
              <a:ext cx="5613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HT3</a:t>
              </a:r>
              <a:endParaRPr lang="ko-KR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1039479" y="2417599"/>
              <a:ext cx="5613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HT4</a:t>
              </a:r>
              <a:endParaRPr lang="ko-KR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3277424" y="2395826"/>
              <a:ext cx="5613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HT5</a:t>
              </a:r>
              <a:endParaRPr lang="ko-KR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483885" y="2385287"/>
              <a:ext cx="5613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HT6</a:t>
              </a:r>
              <a:endParaRPr lang="ko-KR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087940" y="4210888"/>
              <a:ext cx="5613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HT7</a:t>
              </a:r>
              <a:endParaRPr lang="ko-KR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3263265" y="4222833"/>
              <a:ext cx="5613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HT8</a:t>
              </a:r>
              <a:endParaRPr lang="ko-KR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5483885" y="4204838"/>
              <a:ext cx="5613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HT9</a:t>
              </a:r>
              <a:endParaRPr lang="ko-KR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1001007" y="6148088"/>
              <a:ext cx="6383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HT10</a:t>
              </a:r>
              <a:endParaRPr lang="ko-KR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25" name="그림 24"/>
          <p:cNvPicPr>
            <a:picLocks noChangeAspect="1"/>
          </p:cNvPicPr>
          <p:nvPr/>
        </p:nvPicPr>
        <p:blipFill rotWithShape="1">
          <a:blip r:embed="rId12"/>
          <a:srcRect l="25333" t="13704" r="26750" b="20518"/>
          <a:stretch/>
        </p:blipFill>
        <p:spPr>
          <a:xfrm>
            <a:off x="4747508" y="6396519"/>
            <a:ext cx="1925473" cy="14868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6" name="TextBox 25"/>
          <p:cNvSpPr txBox="1"/>
          <p:nvPr/>
        </p:nvSpPr>
        <p:spPr>
          <a:xfrm>
            <a:off x="5485833" y="6074952"/>
            <a:ext cx="5453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AP5</a:t>
            </a:r>
            <a:endParaRPr lang="ko-KR" altLang="en-US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506363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 rot="19683571">
            <a:off x="1419977" y="4162590"/>
            <a:ext cx="31771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Col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 rot="19512700">
            <a:off x="1511951" y="4253509"/>
            <a:ext cx="7216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i="1" dirty="0">
                <a:latin typeface="Arial" panose="020B0604020202020204" pitchFamily="34" charset="0"/>
                <a:cs typeface="Arial" panose="020B0604020202020204" pitchFamily="34" charset="0"/>
              </a:rPr>
              <a:t>lht1LHT2ox-1</a:t>
            </a:r>
            <a:endParaRPr lang="ko-KR" altLang="en-US" sz="7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 rot="19512700">
            <a:off x="1759563" y="4253510"/>
            <a:ext cx="7216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i="1" dirty="0">
                <a:latin typeface="Arial" panose="020B0604020202020204" pitchFamily="34" charset="0"/>
                <a:cs typeface="Arial" panose="020B0604020202020204" pitchFamily="34" charset="0"/>
              </a:rPr>
              <a:t>lht1LHT2ox-3</a:t>
            </a:r>
            <a:endParaRPr lang="ko-KR" altLang="en-US" sz="7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 rot="19634568">
            <a:off x="2948644" y="4138585"/>
            <a:ext cx="31771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Col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 rot="19511082">
            <a:off x="2990791" y="4177109"/>
            <a:ext cx="50847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i="1" dirty="0">
                <a:latin typeface="Arial" panose="020B0604020202020204" pitchFamily="34" charset="0"/>
                <a:cs typeface="Arial" panose="020B0604020202020204" pitchFamily="34" charset="0"/>
              </a:rPr>
              <a:t>lht1-101</a:t>
            </a:r>
            <a:endParaRPr lang="ko-KR" altLang="en-US" sz="700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 rot="19512700">
            <a:off x="3019724" y="4251008"/>
            <a:ext cx="72167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i="1" dirty="0">
                <a:latin typeface="Arial" panose="020B0604020202020204" pitchFamily="34" charset="0"/>
                <a:cs typeface="Arial" panose="020B0604020202020204" pitchFamily="34" charset="0"/>
              </a:rPr>
              <a:t>lht1LHT3ox-7</a:t>
            </a:r>
            <a:endParaRPr lang="ko-KR" altLang="en-US" sz="7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 rot="19512700">
            <a:off x="3217352" y="4268462"/>
            <a:ext cx="77136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i="1" dirty="0">
                <a:latin typeface="Arial" panose="020B0604020202020204" pitchFamily="34" charset="0"/>
                <a:cs typeface="Arial" panose="020B0604020202020204" pitchFamily="34" charset="0"/>
              </a:rPr>
              <a:t>lht1LHT3ox-17</a:t>
            </a:r>
            <a:endParaRPr lang="ko-KR" altLang="en-US" sz="7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1" name="차트 2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49259566"/>
              </p:ext>
            </p:extLst>
          </p:nvPr>
        </p:nvGraphicFramePr>
        <p:xfrm>
          <a:off x="2621001" y="2905566"/>
          <a:ext cx="1458328" cy="128016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2" name="차트 2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08419773"/>
              </p:ext>
            </p:extLst>
          </p:nvPr>
        </p:nvGraphicFramePr>
        <p:xfrm>
          <a:off x="1099183" y="2933959"/>
          <a:ext cx="1384315" cy="12888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8" name="TextBox 27"/>
          <p:cNvSpPr txBox="1"/>
          <p:nvPr/>
        </p:nvSpPr>
        <p:spPr>
          <a:xfrm rot="19634568">
            <a:off x="4381263" y="4180117"/>
            <a:ext cx="31771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Col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 rot="19512700">
            <a:off x="4442579" y="4279000"/>
            <a:ext cx="73129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i="1" dirty="0">
                <a:latin typeface="Arial" panose="020B0604020202020204" pitchFamily="34" charset="0"/>
                <a:cs typeface="Arial" panose="020B0604020202020204" pitchFamily="34" charset="0"/>
              </a:rPr>
              <a:t>lht1AAP5ox-4</a:t>
            </a:r>
            <a:endParaRPr lang="ko-KR" altLang="en-US" sz="7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 rot="19512700">
            <a:off x="4646247" y="4293657"/>
            <a:ext cx="78098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i="1" dirty="0">
                <a:latin typeface="Arial" panose="020B0604020202020204" pitchFamily="34" charset="0"/>
                <a:cs typeface="Arial" panose="020B0604020202020204" pitchFamily="34" charset="0"/>
              </a:rPr>
              <a:t>lht1AAP5ox-14</a:t>
            </a:r>
            <a:endParaRPr lang="ko-KR" altLang="en-US" sz="7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3" name="차트 3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90064686"/>
              </p:ext>
            </p:extLst>
          </p:nvPr>
        </p:nvGraphicFramePr>
        <p:xfrm>
          <a:off x="4109789" y="2841719"/>
          <a:ext cx="1374303" cy="14678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47" name="TextBox 46"/>
          <p:cNvSpPr txBox="1"/>
          <p:nvPr/>
        </p:nvSpPr>
        <p:spPr>
          <a:xfrm rot="16200000">
            <a:off x="3446542" y="3467941"/>
            <a:ext cx="135165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relative expression ( /Col)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 rot="16200000">
            <a:off x="1947314" y="3458648"/>
            <a:ext cx="135165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relative expression ( /Col)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 rot="16200000">
            <a:off x="450880" y="3467942"/>
            <a:ext cx="135165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relative expression ( /Col)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 rot="19511082">
            <a:off x="1480020" y="4192073"/>
            <a:ext cx="50847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i="1" dirty="0">
                <a:latin typeface="Arial" panose="020B0604020202020204" pitchFamily="34" charset="0"/>
                <a:cs typeface="Arial" panose="020B0604020202020204" pitchFamily="34" charset="0"/>
              </a:rPr>
              <a:t>lht1-101</a:t>
            </a:r>
            <a:endParaRPr lang="ko-KR" altLang="en-US" sz="700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 rot="19511082">
            <a:off x="4434444" y="4212778"/>
            <a:ext cx="50847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i="1" dirty="0">
                <a:latin typeface="Arial" panose="020B0604020202020204" pitchFamily="34" charset="0"/>
                <a:cs typeface="Arial" panose="020B0604020202020204" pitchFamily="34" charset="0"/>
              </a:rPr>
              <a:t>lht1-101</a:t>
            </a:r>
            <a:endParaRPr lang="ko-KR" altLang="en-US" sz="700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7" name="그룹 56"/>
          <p:cNvGrpSpPr>
            <a:grpSpLocks noChangeAspect="1"/>
          </p:cNvGrpSpPr>
          <p:nvPr/>
        </p:nvGrpSpPr>
        <p:grpSpPr>
          <a:xfrm>
            <a:off x="1057507" y="2098316"/>
            <a:ext cx="4309385" cy="422294"/>
            <a:chOff x="2327337" y="865449"/>
            <a:chExt cx="4732917" cy="463797"/>
          </a:xfrm>
        </p:grpSpPr>
        <p:grpSp>
          <p:nvGrpSpPr>
            <p:cNvPr id="58" name="그룹 57"/>
            <p:cNvGrpSpPr>
              <a:grpSpLocks noChangeAspect="1"/>
            </p:cNvGrpSpPr>
            <p:nvPr/>
          </p:nvGrpSpPr>
          <p:grpSpPr>
            <a:xfrm>
              <a:off x="2327337" y="865449"/>
              <a:ext cx="4732917" cy="463797"/>
              <a:chOff x="917908" y="1080057"/>
              <a:chExt cx="6233112" cy="610807"/>
            </a:xfrm>
          </p:grpSpPr>
          <p:cxnSp>
            <p:nvCxnSpPr>
              <p:cNvPr id="61" name="직선 연결선 60"/>
              <p:cNvCxnSpPr/>
              <p:nvPr/>
            </p:nvCxnSpPr>
            <p:spPr>
              <a:xfrm flipV="1">
                <a:off x="917908" y="1465842"/>
                <a:ext cx="6233112" cy="13555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2" name="오른쪽 화살표 61"/>
              <p:cNvSpPr/>
              <p:nvPr/>
            </p:nvSpPr>
            <p:spPr>
              <a:xfrm>
                <a:off x="3289060" y="1258135"/>
                <a:ext cx="1003934" cy="432729"/>
              </a:xfrm>
              <a:prstGeom prst="rightArrow">
                <a:avLst/>
              </a:prstGeom>
              <a:solidFill>
                <a:schemeClr val="bg1">
                  <a:lumMod val="75000"/>
                </a:schemeClr>
              </a:solidFill>
              <a:ln>
                <a:solidFill>
                  <a:sysClr val="windowText" lastClr="0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" name="오른쪽 화살표 62"/>
              <p:cNvSpPr/>
              <p:nvPr/>
            </p:nvSpPr>
            <p:spPr>
              <a:xfrm flipH="1">
                <a:off x="1491082" y="1258137"/>
                <a:ext cx="1696359" cy="432727"/>
              </a:xfrm>
              <a:prstGeom prst="rightArrow">
                <a:avLst/>
              </a:prstGeom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" name="TextBox 63"/>
              <p:cNvSpPr txBox="1"/>
              <p:nvPr/>
            </p:nvSpPr>
            <p:spPr>
              <a:xfrm>
                <a:off x="3377183" y="1080057"/>
                <a:ext cx="1017432" cy="311618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35S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" name="TextBox 64"/>
              <p:cNvSpPr txBox="1"/>
              <p:nvPr/>
            </p:nvSpPr>
            <p:spPr>
              <a:xfrm>
                <a:off x="2059429" y="1080057"/>
                <a:ext cx="932019" cy="311618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r>
                  <a:rPr lang="en-US" altLang="ko-KR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HPTII</a:t>
                </a:r>
                <a:endParaRPr lang="ko-KR" alt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" name="TextBox 65"/>
              <p:cNvSpPr txBox="1"/>
              <p:nvPr/>
            </p:nvSpPr>
            <p:spPr>
              <a:xfrm>
                <a:off x="6231325" y="1080060"/>
                <a:ext cx="619898" cy="311619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B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" name="TextBox 66"/>
              <p:cNvSpPr txBox="1"/>
              <p:nvPr/>
            </p:nvSpPr>
            <p:spPr>
              <a:xfrm>
                <a:off x="1139501" y="1080057"/>
                <a:ext cx="606097" cy="311618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LB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" name="직사각형 67"/>
              <p:cNvSpPr/>
              <p:nvPr/>
            </p:nvSpPr>
            <p:spPr>
              <a:xfrm>
                <a:off x="5741778" y="1358301"/>
                <a:ext cx="618140" cy="258381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>
                <a:solidFill>
                  <a:sysClr val="windowText" lastClr="0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" name="TextBox 68"/>
              <p:cNvSpPr txBox="1"/>
              <p:nvPr/>
            </p:nvSpPr>
            <p:spPr>
              <a:xfrm>
                <a:off x="5735730" y="1080059"/>
                <a:ext cx="771324" cy="311619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35S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0" name="직사각형 69"/>
              <p:cNvSpPr/>
              <p:nvPr/>
            </p:nvSpPr>
            <p:spPr>
              <a:xfrm>
                <a:off x="4310739" y="1358301"/>
                <a:ext cx="1410500" cy="258381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" name="직사각형 70"/>
              <p:cNvSpPr/>
              <p:nvPr/>
            </p:nvSpPr>
            <p:spPr>
              <a:xfrm>
                <a:off x="4268191" y="1080057"/>
                <a:ext cx="2077097" cy="311618"/>
              </a:xfrm>
              <a:prstGeom prst="rect">
                <a:avLst/>
              </a:prstGeom>
            </p:spPr>
            <p:txBody>
              <a:bodyPr wrap="square" anchor="t">
                <a:spAutoFit/>
              </a:bodyPr>
              <a:lstStyle/>
              <a:p>
                <a:r>
                  <a:rPr lang="en-US" altLang="ko-KR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LHT2/ LHT3/</a:t>
                </a:r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ko-KR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AAP5</a:t>
                </a:r>
              </a:p>
            </p:txBody>
          </p:sp>
        </p:grpSp>
        <p:sp>
          <p:nvSpPr>
            <p:cNvPr id="59" name="직사각형 58"/>
            <p:cNvSpPr/>
            <p:nvPr/>
          </p:nvSpPr>
          <p:spPr>
            <a:xfrm>
              <a:off x="6467281" y="1078041"/>
              <a:ext cx="144000" cy="196194"/>
            </a:xfrm>
            <a:prstGeom prst="rect">
              <a:avLst/>
            </a:prstGeom>
            <a:solidFill>
              <a:schemeClr val="tx1"/>
            </a:solidFill>
            <a:ln>
              <a:solidFill>
                <a:sysClr val="windowText" lastClr="0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직사각형 59"/>
            <p:cNvSpPr/>
            <p:nvPr/>
          </p:nvSpPr>
          <p:spPr>
            <a:xfrm>
              <a:off x="2596277" y="1080022"/>
              <a:ext cx="144000" cy="196194"/>
            </a:xfrm>
            <a:prstGeom prst="rect">
              <a:avLst/>
            </a:prstGeom>
            <a:solidFill>
              <a:schemeClr val="tx1"/>
            </a:solidFill>
            <a:ln>
              <a:solidFill>
                <a:sysClr val="windowText" lastClr="0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200243" y="4790795"/>
            <a:ext cx="6475765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.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Generation of the transgenic </a:t>
            </a:r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lht1-101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plants overexpressing each amino acid transporter.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A diagram of plant overexpression construct of pH2GW7 with cDNA of indicated amino acid transporter gene.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(B-D)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Quantitative gene expression analysis. Expression level of each amino acid transporter gene was assessed by 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qRT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PCR analysis. For RNA extraction, seedlings were grown on MS-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suc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media under continuous light for 7 days. The relative expression level of each gene in the transgenic lines was normalized to that in wild type (Col), which was set to 1. Values are mean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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SD from three technical replicates.  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875476" y="180716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875476" y="272407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2368448" y="271745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3897518" y="271033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425923" y="2981054"/>
            <a:ext cx="57292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i="1" dirty="0">
                <a:latin typeface="Arial" panose="020B0604020202020204" pitchFamily="34" charset="0"/>
                <a:cs typeface="Arial" panose="020B0604020202020204" pitchFamily="34" charset="0"/>
              </a:rPr>
              <a:t>LHT2</a:t>
            </a:r>
            <a:endParaRPr lang="ko-KR" altLang="en-US" sz="9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2936540" y="3000481"/>
            <a:ext cx="57292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i="1" dirty="0">
                <a:latin typeface="Arial" panose="020B0604020202020204" pitchFamily="34" charset="0"/>
                <a:cs typeface="Arial" panose="020B0604020202020204" pitchFamily="34" charset="0"/>
              </a:rPr>
              <a:t>LHT3</a:t>
            </a:r>
            <a:endParaRPr lang="ko-KR" altLang="en-US" sz="9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4379835" y="3000481"/>
            <a:ext cx="57292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i="1" dirty="0">
                <a:latin typeface="Arial" panose="020B0604020202020204" pitchFamily="34" charset="0"/>
                <a:cs typeface="Arial" panose="020B0604020202020204" pitchFamily="34" charset="0"/>
              </a:rPr>
              <a:t>AAP5</a:t>
            </a:r>
            <a:endParaRPr lang="ko-KR" altLang="en-US" sz="9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2770576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/>
          <p:cNvSpPr txBox="1"/>
          <p:nvPr/>
        </p:nvSpPr>
        <p:spPr>
          <a:xfrm>
            <a:off x="368890" y="4918557"/>
            <a:ext cx="636084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.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ACC-induced root growth inhibition of </a:t>
            </a:r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lht2-1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 lht1-101lht2-1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double mutant. After sterilization, the seeds were kept for 3 days at 4°C, the seeds were sown on half strength of MS-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suc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media containing various concentrations (1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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M, 5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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M, or 10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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M) of ACC as indicated. After irradiation for 12 h, the seedlings were grown in the dark for 3.5 days. Values are mean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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SD (n=15). 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1907923" y="4215778"/>
            <a:ext cx="4791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Col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2811613" y="4215777"/>
            <a:ext cx="7377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lht1-101</a:t>
            </a:r>
            <a:endParaRPr lang="ko-KR" altLang="en-US" sz="1200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4684318" y="4215778"/>
            <a:ext cx="11537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lht1-101lht2-1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 rot="16200000">
            <a:off x="510580" y="2788179"/>
            <a:ext cx="13115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root length (mm)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8" name="차트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35522312"/>
              </p:ext>
            </p:extLst>
          </p:nvPr>
        </p:nvGraphicFramePr>
        <p:xfrm>
          <a:off x="1304869" y="1555078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직사각형 1"/>
          <p:cNvSpPr/>
          <p:nvPr/>
        </p:nvSpPr>
        <p:spPr>
          <a:xfrm>
            <a:off x="3813264" y="4215778"/>
            <a:ext cx="56778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lht2-1</a:t>
            </a:r>
            <a:endParaRPr lang="ko-KR" altLang="en-US" sz="1200" dirty="0"/>
          </a:p>
        </p:txBody>
      </p:sp>
    </p:spTree>
    <p:extLst>
      <p:ext uri="{BB962C8B-B14F-4D97-AF65-F5344CB8AC3E}">
        <p14:creationId xmlns:p14="http://schemas.microsoft.com/office/powerpoint/2010/main" val="131199230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/>
          <p:cNvSpPr txBox="1"/>
          <p:nvPr/>
        </p:nvSpPr>
        <p:spPr>
          <a:xfrm>
            <a:off x="394730" y="7744998"/>
            <a:ext cx="628599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.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Effect of substrates on the </a:t>
            </a:r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LHT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expressing </a:t>
            </a:r>
            <a:r>
              <a:rPr lang="en-US" altLang="ko-KR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Xenopus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oocytes.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Treatment with amino acids or ACC (100 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) did not affect the basal channel in the H</a:t>
            </a:r>
            <a:r>
              <a:rPr lang="en-US" altLang="ko-KR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O-injected control oocytes.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(B and C)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The representative traces of </a:t>
            </a:r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LHT1-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or </a:t>
            </a:r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LHT2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expressing oocytes after addition of various amino acid substrates. Each substrate (100 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) produced a reversible inward current by extracellular application for 1 min. The holding potential was −80 mV. </a:t>
            </a:r>
            <a:endParaRPr lang="ko-KR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05435" y="2862612"/>
            <a:ext cx="2464586" cy="2316265"/>
          </a:xfrm>
          <a:prstGeom prst="rect">
            <a:avLst/>
          </a:prstGeom>
          <a:ln>
            <a:noFill/>
          </a:ln>
        </p:spPr>
      </p:pic>
      <p:pic>
        <p:nvPicPr>
          <p:cNvPr id="4" name="그림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05435" y="1051532"/>
            <a:ext cx="2464586" cy="1811080"/>
          </a:xfrm>
          <a:prstGeom prst="rect">
            <a:avLst/>
          </a:prstGeom>
          <a:ln>
            <a:noFill/>
          </a:ln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05435" y="5178877"/>
            <a:ext cx="2470932" cy="2124331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1990925" y="103050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990925" y="277021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990925" y="512095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9504653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표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48015513"/>
              </p:ext>
            </p:extLst>
          </p:nvPr>
        </p:nvGraphicFramePr>
        <p:xfrm>
          <a:off x="531457" y="564276"/>
          <a:ext cx="5845279" cy="7632381"/>
        </p:xfrm>
        <a:graphic>
          <a:graphicData uri="http://schemas.openxmlformats.org/drawingml/2006/table">
            <a:tbl>
              <a:tblPr/>
              <a:tblGrid>
                <a:gridCol w="864206">
                  <a:extLst>
                    <a:ext uri="{9D8B030D-6E8A-4147-A177-3AD203B41FA5}">
                      <a16:colId xmlns:a16="http://schemas.microsoft.com/office/drawing/2014/main" val="4192605878"/>
                    </a:ext>
                  </a:extLst>
                </a:gridCol>
                <a:gridCol w="902369">
                  <a:extLst>
                    <a:ext uri="{9D8B030D-6E8A-4147-A177-3AD203B41FA5}">
                      <a16:colId xmlns:a16="http://schemas.microsoft.com/office/drawing/2014/main" val="2600083163"/>
                    </a:ext>
                  </a:extLst>
                </a:gridCol>
                <a:gridCol w="548763">
                  <a:extLst>
                    <a:ext uri="{9D8B030D-6E8A-4147-A177-3AD203B41FA5}">
                      <a16:colId xmlns:a16="http://schemas.microsoft.com/office/drawing/2014/main" val="2107846375"/>
                    </a:ext>
                  </a:extLst>
                </a:gridCol>
                <a:gridCol w="559856">
                  <a:extLst>
                    <a:ext uri="{9D8B030D-6E8A-4147-A177-3AD203B41FA5}">
                      <a16:colId xmlns:a16="http://schemas.microsoft.com/office/drawing/2014/main" val="273551993"/>
                    </a:ext>
                  </a:extLst>
                </a:gridCol>
                <a:gridCol w="2007560">
                  <a:extLst>
                    <a:ext uri="{9D8B030D-6E8A-4147-A177-3AD203B41FA5}">
                      <a16:colId xmlns:a16="http://schemas.microsoft.com/office/drawing/2014/main" val="2940635862"/>
                    </a:ext>
                  </a:extLst>
                </a:gridCol>
                <a:gridCol w="962525">
                  <a:extLst>
                    <a:ext uri="{9D8B030D-6E8A-4147-A177-3AD203B41FA5}">
                      <a16:colId xmlns:a16="http://schemas.microsoft.com/office/drawing/2014/main" val="1929384168"/>
                    </a:ext>
                  </a:extLst>
                </a:gridCol>
              </a:tblGrid>
              <a:tr h="130501">
                <a:tc gridSpan="5"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Supplementary Table S1. 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List of primers used in this study.</a:t>
                      </a:r>
                    </a:p>
                  </a:txBody>
                  <a:tcPr marL="5220" marR="5220" marT="52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68883754"/>
                  </a:ext>
                </a:extLst>
              </a:tr>
              <a:tr h="130501">
                <a:tc gridSpan="3">
                  <a:txBody>
                    <a:bodyPr/>
                    <a:lstStyle/>
                    <a:p>
                      <a:pPr algn="l" fontAlgn="ctr"/>
                      <a:endParaRPr lang="ko-KR" altLang="en-US" sz="10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96486875"/>
                  </a:ext>
                </a:extLst>
              </a:tr>
              <a:tr h="328053">
                <a:tc gridSpan="5"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Primer sets for cloning of cDNA</a:t>
                      </a:r>
                    </a:p>
                  </a:txBody>
                  <a:tcPr marL="5220" marR="5220" marT="52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ko-KR" alt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5220" marR="5220" marT="52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86178605"/>
                  </a:ext>
                </a:extLst>
              </a:tr>
              <a:tr h="19125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gene </a:t>
                      </a:r>
                    </a:p>
                  </a:txBody>
                  <a:tcPr marL="5220" marR="5220" marT="52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AGI </a:t>
                      </a: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primer sequence</a:t>
                      </a: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vector</a:t>
                      </a: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04432734"/>
                  </a:ext>
                </a:extLst>
              </a:tr>
              <a:tr h="214021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LHT2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 cDNA</a:t>
                      </a:r>
                    </a:p>
                  </a:txBody>
                  <a:tcPr marL="5220" marR="5220" marT="52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AT1G24400</a:t>
                      </a: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'-GGATCCAGATGGGGAACAGTGAAATGTCA-3'</a:t>
                      </a: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pENTR1A</a:t>
                      </a: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01221821"/>
                  </a:ext>
                </a:extLst>
              </a:tr>
              <a:tr h="214021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'-CTCGAGATCTAAGAGAAGAACTTGTAGGT-3'</a:t>
                      </a: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28208079"/>
                  </a:ext>
                </a:extLst>
              </a:tr>
              <a:tr h="214021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LHT3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 cDNA</a:t>
                      </a:r>
                    </a:p>
                  </a:txBody>
                  <a:tcPr marL="5220" marR="5220" marT="52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AT1G61270</a:t>
                      </a: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'-GGATCCAGATGAAAGGAATCCCAAGTTCG-3'</a:t>
                      </a: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pENTR1A</a:t>
                      </a: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41260487"/>
                  </a:ext>
                </a:extLst>
              </a:tr>
              <a:tr h="214021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'-CTCGAGATTTAGGTGCTTTTGCAACTGGA-3'</a:t>
                      </a: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31438047"/>
                  </a:ext>
                </a:extLst>
              </a:tr>
              <a:tr h="214021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AAP5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 cDNA</a:t>
                      </a:r>
                    </a:p>
                  </a:txBody>
                  <a:tcPr marL="5220" marR="5220" marT="52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AT1G44100</a:t>
                      </a: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'-CACCATGGTCGTTCAGAATGTTCAAG-3'</a:t>
                      </a: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pENT-D-TOPO</a:t>
                      </a: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71866563"/>
                  </a:ext>
                </a:extLst>
              </a:tr>
              <a:tr h="214021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'-GAATTCAGACTGGAAAGGTTTGTAG-3'</a:t>
                      </a: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14238848"/>
                  </a:ext>
                </a:extLst>
              </a:tr>
              <a:tr h="214021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LHT1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 cDNA</a:t>
                      </a:r>
                    </a:p>
                  </a:txBody>
                  <a:tcPr marL="5220" marR="5220" marT="52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AT5G40780</a:t>
                      </a: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'-GCATGCAGATGGTAGCTCAAGCTCCTCA -3'</a:t>
                      </a: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pGEM-HE</a:t>
                      </a: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01993941"/>
                  </a:ext>
                </a:extLst>
              </a:tr>
              <a:tr h="214021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'-GAATTCATTGAGTAAAACTTGTATCCTT -3'</a:t>
                      </a: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44762566"/>
                  </a:ext>
                </a:extLst>
              </a:tr>
              <a:tr h="214021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LHT2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 cDNA</a:t>
                      </a:r>
                    </a:p>
                  </a:txBody>
                  <a:tcPr marL="5220" marR="5220" marT="52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AT1G24400</a:t>
                      </a: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'-GCATGCAGATGGGGAACAGTGAAATGTCA -3'</a:t>
                      </a: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pGEM-HE</a:t>
                      </a: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1558032"/>
                  </a:ext>
                </a:extLst>
              </a:tr>
              <a:tr h="214021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'-GAGCTCATAGAGAAGAACTTGTAGGTCTTGG -3'</a:t>
                      </a: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23349025"/>
                  </a:ext>
                </a:extLst>
              </a:tr>
              <a:tr h="288960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Primer sets for </a:t>
                      </a:r>
                      <a:r>
                        <a:rPr lang="en-US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qRT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-PCR</a:t>
                      </a:r>
                    </a:p>
                  </a:txBody>
                  <a:tcPr marL="5220" marR="5220" marT="5220" marB="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ko-KR" alt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5220" marR="5220" marT="52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ko-KR" alt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27002036"/>
                  </a:ext>
                </a:extLst>
              </a:tr>
              <a:tr h="20562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gene</a:t>
                      </a:r>
                    </a:p>
                  </a:txBody>
                  <a:tcPr marL="5220" marR="5220" marT="52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AGI</a:t>
                      </a: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primer sequence</a:t>
                      </a: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03479897"/>
                  </a:ext>
                </a:extLst>
              </a:tr>
              <a:tr h="130501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LHT2</a:t>
                      </a:r>
                    </a:p>
                  </a:txBody>
                  <a:tcPr marL="5220" marR="5220" marT="52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AT1G24400</a:t>
                      </a: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'-TCGGCTTCTTTGGAGGATTCGC-3'</a:t>
                      </a: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57425701"/>
                  </a:ext>
                </a:extLst>
              </a:tr>
              <a:tr h="250244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'-ACGAGCCACATAATGCATGGAAGG-3'</a:t>
                      </a: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43134939"/>
                  </a:ext>
                </a:extLst>
              </a:tr>
              <a:tr h="130501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LHT3</a:t>
                      </a:r>
                    </a:p>
                  </a:txBody>
                  <a:tcPr marL="5220" marR="5220" marT="52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AT1G61270</a:t>
                      </a: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'-AGCTAGGACAAGCAGCCTTT-3'</a:t>
                      </a: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05924603"/>
                  </a:ext>
                </a:extLst>
              </a:tr>
              <a:tr h="251582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'-TTTGTCAGTGAAGCTACCCAA-3'</a:t>
                      </a: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35077552"/>
                  </a:ext>
                </a:extLst>
              </a:tr>
              <a:tr h="214021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AAP5</a:t>
                      </a:r>
                    </a:p>
                  </a:txBody>
                  <a:tcPr marL="5220" marR="5220" marT="52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AT1G44100</a:t>
                      </a: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'-TGGACGCTATTCACTCCAACCTC-3'</a:t>
                      </a: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16423847"/>
                  </a:ext>
                </a:extLst>
              </a:tr>
              <a:tr h="214021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'-GCAACTTGTCCTTTGGATTGCTAC-3'</a:t>
                      </a: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41663880"/>
                  </a:ext>
                </a:extLst>
              </a:tr>
              <a:tr h="214021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PR1</a:t>
                      </a:r>
                    </a:p>
                  </a:txBody>
                  <a:tcPr marL="5220" marR="5220" marT="52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AT2G14610</a:t>
                      </a: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'-TTCCCTCGAAAGCTCAAGATAGCC-3'</a:t>
                      </a: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60873976"/>
                  </a:ext>
                </a:extLst>
              </a:tr>
              <a:tr h="214021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'-CGTAAGGCCCACCAGAGTGTATGA-3'</a:t>
                      </a: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87616099"/>
                  </a:ext>
                </a:extLst>
              </a:tr>
              <a:tr h="214021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SRG1</a:t>
                      </a:r>
                    </a:p>
                  </a:txBody>
                  <a:tcPr marL="5220" marR="5220" marT="52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AT1G17020</a:t>
                      </a: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'-CGGTCGGACTCACTGTACTGATGC-3'</a:t>
                      </a: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43087217"/>
                  </a:ext>
                </a:extLst>
              </a:tr>
              <a:tr h="214021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'-CAACTCCGCGATGCTCTATGCTT-3'</a:t>
                      </a: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87306974"/>
                  </a:ext>
                </a:extLst>
              </a:tr>
              <a:tr h="130501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SAG12</a:t>
                      </a:r>
                    </a:p>
                  </a:txBody>
                  <a:tcPr marL="5220" marR="5220" marT="52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AT5G45890</a:t>
                      </a: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'-CGGATGTGAAGGAGGAAAA-3'</a:t>
                      </a: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25724340"/>
                  </a:ext>
                </a:extLst>
              </a:tr>
              <a:tr h="242547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'-CAATGCGTTCGACGTTGTTT-3'</a:t>
                      </a: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80332372"/>
                  </a:ext>
                </a:extLst>
              </a:tr>
              <a:tr h="130501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PAD4</a:t>
                      </a:r>
                    </a:p>
                  </a:txBody>
                  <a:tcPr marL="5220" marR="5220" marT="52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AT3G52430</a:t>
                      </a: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'-CCGATGAACCTCTACCTA-3'</a:t>
                      </a: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30834894"/>
                  </a:ext>
                </a:extLst>
              </a:tr>
              <a:tr h="239422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'-CCTAACAATTCCAATTCCAAT-3'</a:t>
                      </a: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34763885"/>
                  </a:ext>
                </a:extLst>
              </a:tr>
              <a:tr h="130501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ICS1</a:t>
                      </a:r>
                    </a:p>
                  </a:txBody>
                  <a:tcPr marL="5220" marR="5220" marT="52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AT1G74710</a:t>
                      </a: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'-TTCTTCCGTGACCTTGAT-3'</a:t>
                      </a: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78098338"/>
                  </a:ext>
                </a:extLst>
              </a:tr>
              <a:tr h="251454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'-AACGCATACCACCATAGG-3'</a:t>
                      </a: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73483669"/>
                  </a:ext>
                </a:extLst>
              </a:tr>
              <a:tr h="130501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NHL25</a:t>
                      </a:r>
                    </a:p>
                  </a:txBody>
                  <a:tcPr marL="5220" marR="5220" marT="52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AT5G36970</a:t>
                      </a: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'-GTTGCGGATTAGAGTTACC-3'</a:t>
                      </a: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75278570"/>
                  </a:ext>
                </a:extLst>
              </a:tr>
              <a:tr h="239422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'-CGGATACACCACACCTAA-3'</a:t>
                      </a: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07514119"/>
                  </a:ext>
                </a:extLst>
              </a:tr>
              <a:tr h="214021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PP2A</a:t>
                      </a:r>
                    </a:p>
                  </a:txBody>
                  <a:tcPr marL="5220" marR="5220" marT="52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AT1G13320</a:t>
                      </a: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'-TATCGGATGACGATTCTTCGTGCAG-3'</a:t>
                      </a: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60550188"/>
                  </a:ext>
                </a:extLst>
              </a:tr>
              <a:tr h="214021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5'-GCTTGGTCGACTATCGGAATGAGAG-3'</a:t>
                      </a: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5220" marR="5220" marT="52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4614237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26983434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표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4960216"/>
              </p:ext>
            </p:extLst>
          </p:nvPr>
        </p:nvGraphicFramePr>
        <p:xfrm>
          <a:off x="324856" y="596220"/>
          <a:ext cx="6232356" cy="8066524"/>
        </p:xfrm>
        <a:graphic>
          <a:graphicData uri="http://schemas.openxmlformats.org/drawingml/2006/table">
            <a:tbl>
              <a:tblPr/>
              <a:tblGrid>
                <a:gridCol w="1267951">
                  <a:extLst>
                    <a:ext uri="{9D8B030D-6E8A-4147-A177-3AD203B41FA5}">
                      <a16:colId xmlns:a16="http://schemas.microsoft.com/office/drawing/2014/main" val="3759063167"/>
                    </a:ext>
                  </a:extLst>
                </a:gridCol>
                <a:gridCol w="2251824">
                  <a:extLst>
                    <a:ext uri="{9D8B030D-6E8A-4147-A177-3AD203B41FA5}">
                      <a16:colId xmlns:a16="http://schemas.microsoft.com/office/drawing/2014/main" val="403370574"/>
                    </a:ext>
                  </a:extLst>
                </a:gridCol>
                <a:gridCol w="2712581">
                  <a:extLst>
                    <a:ext uri="{9D8B030D-6E8A-4147-A177-3AD203B41FA5}">
                      <a16:colId xmlns:a16="http://schemas.microsoft.com/office/drawing/2014/main" val="3986278222"/>
                    </a:ext>
                  </a:extLst>
                </a:gridCol>
              </a:tblGrid>
              <a:tr h="477727"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Supplementary Table S2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. Evidence for normality of distribution and homoscedasticity of variances of </a:t>
                      </a: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Figure 4B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.</a:t>
                      </a:r>
                    </a:p>
                  </a:txBody>
                  <a:tcPr marL="7317" marR="7317" marT="73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79203500"/>
                  </a:ext>
                </a:extLst>
              </a:tr>
              <a:tr h="243591">
                <a:tc>
                  <a:txBody>
                    <a:bodyPr/>
                    <a:lstStyle/>
                    <a:p>
                      <a:pPr algn="l" fontAlgn="ctr"/>
                      <a:endParaRPr lang="ko-KR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7317" marR="7317" marT="73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7317" marR="7317" marT="73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7317" marR="7317" marT="73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24017454"/>
                  </a:ext>
                </a:extLst>
              </a:tr>
              <a:tr h="25296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D-Ala</a:t>
                      </a:r>
                    </a:p>
                  </a:txBody>
                  <a:tcPr marL="7317" marR="7317" marT="73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normality of distribution</a:t>
                      </a:r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* (p value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7317" marR="7317" marT="73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homoscedasticity of variances</a:t>
                      </a:r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** (p value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7317" marR="7317" marT="73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48704586"/>
                  </a:ext>
                </a:extLst>
              </a:tr>
              <a:tr h="24359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ol</a:t>
                      </a:r>
                    </a:p>
                  </a:txBody>
                  <a:tcPr marL="7317" marR="7317" marT="73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316</a:t>
                      </a:r>
                    </a:p>
                  </a:txBody>
                  <a:tcPr marL="7317" marR="7317" marT="73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234</a:t>
                      </a:r>
                    </a:p>
                  </a:txBody>
                  <a:tcPr marL="7317" marR="7317" marT="73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53975845"/>
                  </a:ext>
                </a:extLst>
              </a:tr>
              <a:tr h="24359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lht1-101</a:t>
                      </a:r>
                    </a:p>
                  </a:txBody>
                  <a:tcPr marL="7317" marR="7317" marT="73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514</a:t>
                      </a:r>
                    </a:p>
                  </a:txBody>
                  <a:tcPr marL="7317" marR="7317" marT="73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94618151"/>
                  </a:ext>
                </a:extLst>
              </a:tr>
              <a:tr h="24359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lht1LHT2ox-1</a:t>
                      </a:r>
                    </a:p>
                  </a:txBody>
                  <a:tcPr marL="7317" marR="7317" marT="73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495</a:t>
                      </a:r>
                    </a:p>
                  </a:txBody>
                  <a:tcPr marL="7317" marR="7317" marT="73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01624436"/>
                  </a:ext>
                </a:extLst>
              </a:tr>
              <a:tr h="24359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lht1LHT3ox-17</a:t>
                      </a:r>
                    </a:p>
                  </a:txBody>
                  <a:tcPr marL="7317" marR="7317" marT="73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935</a:t>
                      </a:r>
                    </a:p>
                  </a:txBody>
                  <a:tcPr marL="7317" marR="7317" marT="73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12194522"/>
                  </a:ext>
                </a:extLst>
              </a:tr>
              <a:tr h="24359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lht1AAP5ox-14</a:t>
                      </a:r>
                    </a:p>
                  </a:txBody>
                  <a:tcPr marL="7317" marR="7317" marT="73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751</a:t>
                      </a:r>
                    </a:p>
                  </a:txBody>
                  <a:tcPr marL="7317" marR="7317" marT="73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77405640"/>
                  </a:ext>
                </a:extLst>
              </a:tr>
              <a:tr h="243591">
                <a:tc>
                  <a:txBody>
                    <a:bodyPr/>
                    <a:lstStyle/>
                    <a:p>
                      <a:pPr algn="l" fontAlgn="ctr"/>
                      <a:endParaRPr lang="ko-KR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7317" marR="7317" marT="731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7317" marR="7317" marT="731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7317" marR="7317" marT="731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82543872"/>
                  </a:ext>
                </a:extLst>
              </a:tr>
              <a:tr h="25296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D-Met</a:t>
                      </a:r>
                    </a:p>
                  </a:txBody>
                  <a:tcPr marL="7317" marR="7317" marT="73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normality of distribution </a:t>
                      </a:r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p value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7317" marR="7317" marT="73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homoscedasticity of variances </a:t>
                      </a:r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p value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7317" marR="7317" marT="73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3360956"/>
                  </a:ext>
                </a:extLst>
              </a:tr>
              <a:tr h="24359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ol</a:t>
                      </a:r>
                    </a:p>
                  </a:txBody>
                  <a:tcPr marL="7317" marR="7317" marT="73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99</a:t>
                      </a:r>
                    </a:p>
                  </a:txBody>
                  <a:tcPr marL="7317" marR="7317" marT="73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234</a:t>
                      </a:r>
                    </a:p>
                  </a:txBody>
                  <a:tcPr marL="7317" marR="7317" marT="73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14902744"/>
                  </a:ext>
                </a:extLst>
              </a:tr>
              <a:tr h="24359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lht1-101</a:t>
                      </a:r>
                    </a:p>
                  </a:txBody>
                  <a:tcPr marL="7317" marR="7317" marT="73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201</a:t>
                      </a:r>
                    </a:p>
                  </a:txBody>
                  <a:tcPr marL="7317" marR="7317" marT="73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245935"/>
                  </a:ext>
                </a:extLst>
              </a:tr>
              <a:tr h="24359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lht1LHT2ox-1</a:t>
                      </a:r>
                    </a:p>
                  </a:txBody>
                  <a:tcPr marL="7317" marR="7317" marT="73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812</a:t>
                      </a:r>
                    </a:p>
                  </a:txBody>
                  <a:tcPr marL="7317" marR="7317" marT="73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70143841"/>
                  </a:ext>
                </a:extLst>
              </a:tr>
              <a:tr h="24359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lht1LHT3ox-17</a:t>
                      </a:r>
                    </a:p>
                  </a:txBody>
                  <a:tcPr marL="7317" marR="7317" marT="73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686</a:t>
                      </a:r>
                    </a:p>
                  </a:txBody>
                  <a:tcPr marL="7317" marR="7317" marT="73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14915435"/>
                  </a:ext>
                </a:extLst>
              </a:tr>
              <a:tr h="24359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lht1AAP5ox-14</a:t>
                      </a:r>
                    </a:p>
                  </a:txBody>
                  <a:tcPr marL="7317" marR="7317" marT="73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06</a:t>
                      </a:r>
                    </a:p>
                  </a:txBody>
                  <a:tcPr marL="7317" marR="7317" marT="73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66605238"/>
                  </a:ext>
                </a:extLst>
              </a:tr>
              <a:tr h="243591">
                <a:tc>
                  <a:txBody>
                    <a:bodyPr/>
                    <a:lstStyle/>
                    <a:p>
                      <a:pPr algn="l" fontAlgn="ctr"/>
                      <a:endParaRPr lang="ko-KR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7317" marR="7317" marT="731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7317" marR="7317" marT="731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7317" marR="7317" marT="731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57897323"/>
                  </a:ext>
                </a:extLst>
              </a:tr>
              <a:tr h="25296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D-Phe</a:t>
                      </a:r>
                    </a:p>
                  </a:txBody>
                  <a:tcPr marL="7317" marR="7317" marT="73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normality of distribution </a:t>
                      </a:r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p value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7317" marR="7317" marT="73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homoscedasticity of variances </a:t>
                      </a:r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p value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7317" marR="7317" marT="73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21728091"/>
                  </a:ext>
                </a:extLst>
              </a:tr>
              <a:tr h="24359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ol</a:t>
                      </a:r>
                    </a:p>
                  </a:txBody>
                  <a:tcPr marL="7317" marR="7317" marT="73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68</a:t>
                      </a:r>
                    </a:p>
                  </a:txBody>
                  <a:tcPr marL="7317" marR="7317" marT="73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145</a:t>
                      </a:r>
                    </a:p>
                  </a:txBody>
                  <a:tcPr marL="7317" marR="7317" marT="73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51661428"/>
                  </a:ext>
                </a:extLst>
              </a:tr>
              <a:tr h="24359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lht1-101</a:t>
                      </a:r>
                    </a:p>
                  </a:txBody>
                  <a:tcPr marL="7317" marR="7317" marT="73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419</a:t>
                      </a:r>
                    </a:p>
                  </a:txBody>
                  <a:tcPr marL="7317" marR="7317" marT="73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41293682"/>
                  </a:ext>
                </a:extLst>
              </a:tr>
              <a:tr h="24359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lht1LHT2ox-1</a:t>
                      </a:r>
                    </a:p>
                  </a:txBody>
                  <a:tcPr marL="7317" marR="7317" marT="73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962</a:t>
                      </a:r>
                    </a:p>
                  </a:txBody>
                  <a:tcPr marL="7317" marR="7317" marT="73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25112926"/>
                  </a:ext>
                </a:extLst>
              </a:tr>
              <a:tr h="24359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lht1LHT3ox-17</a:t>
                      </a:r>
                    </a:p>
                  </a:txBody>
                  <a:tcPr marL="7317" marR="7317" marT="73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782</a:t>
                      </a:r>
                    </a:p>
                  </a:txBody>
                  <a:tcPr marL="7317" marR="7317" marT="73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76686697"/>
                  </a:ext>
                </a:extLst>
              </a:tr>
              <a:tr h="24359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lht1AAP5ox-14</a:t>
                      </a:r>
                    </a:p>
                  </a:txBody>
                  <a:tcPr marL="7317" marR="7317" marT="73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305</a:t>
                      </a:r>
                    </a:p>
                  </a:txBody>
                  <a:tcPr marL="7317" marR="7317" marT="73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32113032"/>
                  </a:ext>
                </a:extLst>
              </a:tr>
              <a:tr h="243591">
                <a:tc>
                  <a:txBody>
                    <a:bodyPr/>
                    <a:lstStyle/>
                    <a:p>
                      <a:pPr algn="l" fontAlgn="ctr"/>
                      <a:endParaRPr lang="ko-KR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7317" marR="7317" marT="731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7317" marR="7317" marT="731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7317" marR="7317" marT="731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2836288"/>
                  </a:ext>
                </a:extLst>
              </a:tr>
              <a:tr h="25296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MS</a:t>
                      </a:r>
                    </a:p>
                  </a:txBody>
                  <a:tcPr marL="7317" marR="7317" marT="73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normality of distribution </a:t>
                      </a:r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p value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7317" marR="7317" marT="73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homoscedasticity of variances </a:t>
                      </a:r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p value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7317" marR="7317" marT="73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36246607"/>
                  </a:ext>
                </a:extLst>
              </a:tr>
              <a:tr h="24359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ol</a:t>
                      </a:r>
                    </a:p>
                  </a:txBody>
                  <a:tcPr marL="7317" marR="7317" marT="73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021</a:t>
                      </a:r>
                    </a:p>
                  </a:txBody>
                  <a:tcPr marL="7317" marR="7317" marT="73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153</a:t>
                      </a:r>
                    </a:p>
                  </a:txBody>
                  <a:tcPr marL="7317" marR="7317" marT="73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67205503"/>
                  </a:ext>
                </a:extLst>
              </a:tr>
              <a:tr h="24359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lht1-101</a:t>
                      </a:r>
                    </a:p>
                  </a:txBody>
                  <a:tcPr marL="7317" marR="7317" marT="73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255</a:t>
                      </a:r>
                    </a:p>
                  </a:txBody>
                  <a:tcPr marL="7317" marR="7317" marT="73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20241757"/>
                  </a:ext>
                </a:extLst>
              </a:tr>
              <a:tr h="24359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lht1LHT2ox-1</a:t>
                      </a:r>
                    </a:p>
                  </a:txBody>
                  <a:tcPr marL="7317" marR="7317" marT="73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682</a:t>
                      </a:r>
                    </a:p>
                  </a:txBody>
                  <a:tcPr marL="7317" marR="7317" marT="73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79387652"/>
                  </a:ext>
                </a:extLst>
              </a:tr>
              <a:tr h="24359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lht1LHT3ox-17</a:t>
                      </a:r>
                    </a:p>
                  </a:txBody>
                  <a:tcPr marL="7317" marR="7317" marT="73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738</a:t>
                      </a:r>
                    </a:p>
                  </a:txBody>
                  <a:tcPr marL="7317" marR="7317" marT="73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4774424"/>
                  </a:ext>
                </a:extLst>
              </a:tr>
              <a:tr h="24359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lht1AAP5ox-14</a:t>
                      </a:r>
                    </a:p>
                  </a:txBody>
                  <a:tcPr marL="7317" marR="7317" marT="73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0.538</a:t>
                      </a:r>
                    </a:p>
                  </a:txBody>
                  <a:tcPr marL="7317" marR="7317" marT="73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20728634"/>
                  </a:ext>
                </a:extLst>
              </a:tr>
              <a:tr h="243591">
                <a:tc>
                  <a:txBody>
                    <a:bodyPr/>
                    <a:lstStyle/>
                    <a:p>
                      <a:pPr algn="l" fontAlgn="ctr"/>
                      <a:endParaRPr lang="ko-KR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7317" marR="7317" marT="731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7317" marR="7317" marT="731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7317" marR="7317" marT="731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81988163"/>
                  </a:ext>
                </a:extLst>
              </a:tr>
              <a:tr h="243591"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* normality of distribution evaluated by Shapiro-Wilk test</a:t>
                      </a:r>
                    </a:p>
                  </a:txBody>
                  <a:tcPr marL="7317" marR="7317" marT="73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16702372"/>
                  </a:ext>
                </a:extLst>
              </a:tr>
              <a:tr h="243591"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** homoscedasticity of variances evaluated by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Levene's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 test</a:t>
                      </a:r>
                    </a:p>
                  </a:txBody>
                  <a:tcPr marL="7317" marR="7317" marT="731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8782350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680417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>
        <a:ln w="19050">
          <a:solidFill>
            <a:schemeClr val="bg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738</Words>
  <Application>Microsoft Office PowerPoint</Application>
  <PresentationFormat>A4 Paper (210x297 mm)</PresentationFormat>
  <Paragraphs>187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2" baseType="lpstr">
      <vt:lpstr>맑은 고딕</vt:lpstr>
      <vt:lpstr>Arial</vt:lpstr>
      <vt:lpstr>Calibri</vt:lpstr>
      <vt:lpstr>Calibri Light</vt:lpstr>
      <vt:lpstr>Times New Roman</vt:lpstr>
      <vt:lpstr>Office 테마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Lee Sumin</dc:creator>
  <cp:lastModifiedBy>Sidra Amiri</cp:lastModifiedBy>
  <cp:revision>300</cp:revision>
  <cp:lastPrinted>2019-03-27T11:51:38Z</cp:lastPrinted>
  <dcterms:created xsi:type="dcterms:W3CDTF">2019-01-03T06:26:06Z</dcterms:created>
  <dcterms:modified xsi:type="dcterms:W3CDTF">2019-08-26T07:52:41Z</dcterms:modified>
</cp:coreProperties>
</file>